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7351A6D1-B092-D87E-287E-011F103EE6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7200117E-E30E-D935-5AF1-369F194AE7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E6D93A60-5BF4-22BC-DB31-D00AB86B4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A095F155-6728-8DA6-E1EA-EAE288A31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62A57EE-9540-641D-4DF2-1EE6964B4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8013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19C1878-8DE5-1144-715C-AB6CF3E69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788CCF38-2EFB-8B64-B951-AAFCFA3CF8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55F6B6A1-755F-899C-5A84-2ED7F1F97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5480ACD4-DD47-F3BB-5F51-D420065A8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67758FA7-D056-CE35-86F2-801D3A8F0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25744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78E00309-22D0-625A-5405-97439B01BD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00343809-4B00-0DB9-6839-11BDF33CAA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B26DEF85-B05D-9C41-577E-C1F246284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034E40AB-15C4-1974-A4ED-94C059C9F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E522F7D9-7D7C-F311-D805-ED2E16EB3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27922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7C806FA0-5B49-BF62-E7A1-C0DD03DE9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0C7E23B1-C7BC-71D7-3688-FA5F467482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4E5915A5-0589-5081-1B77-532DD8880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848183DA-50B3-9840-9A65-86D41355C4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9CC9A855-5556-83D5-2783-BBD34DD21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905508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72E2E54B-FB11-DFF3-B7D0-A1DAEB8CB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8EA52BF9-1986-DFE6-9BA7-1933BD12E9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E0D82768-08B7-BCD8-ECB8-B8D88BAD8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A68AA177-92B8-B671-485D-258B923E5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B97B7856-F675-D9BE-6861-00C641CAF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34564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70D58C4-FE66-EDFA-7A8F-4AD18F70D9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E79D6EBE-DCA0-34FA-54B2-8F586F1435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AD7C4AB2-A8F9-6CC8-90B4-451193C3F8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C5F0DDDB-FACB-C490-6496-4B1D62081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B2C95457-D975-7C10-6CEE-87AA72077C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B4EB5719-0C2F-CB59-C26A-1C0EB20CA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26253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17858004-D9FB-30C5-6F4C-417618F551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39EF6EED-8511-78CB-351C-46DB2071E5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D11B5BE0-BE4B-7DAB-0D59-A19994FE77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F86BFB16-84E2-CFBE-395D-B307D4D32A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F387B7F7-7794-1C14-9DDB-AEC77EA448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B11E56BB-D623-EFAF-282A-376B741F2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6ECFA7BD-7A3F-5590-AB6B-CF7878FC6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3BA55958-3E46-34A6-D6F6-BBF8FC869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68368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3AE18ED5-5E31-3B93-645E-E10DE24F36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D29C8120-1AF3-C8DA-51BD-47F1AF99F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D359F956-B99D-41A4-AC12-D3069A07B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1365B1FD-ED0E-A1F0-C02C-72D5829C8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705327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4C1DED63-BC57-3A8C-7248-A52C73DD1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DA32CB6E-6A2B-30F7-D95D-7D3BD57B3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A628D6D5-5F4A-86C7-BB90-1446691E4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233358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F740A5DB-7DAE-521A-8E3A-EEC02B1367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E7FC48DC-FFC0-FD40-77CC-6230DC2FA6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CDB7E641-D9B2-48E1-5A18-AFC4873016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ED8EB025-3DD5-5E8C-EC37-507CEC7B6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349C550D-63CF-4502-4578-C8EB9799C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72009CA5-C647-3B74-88E0-99897676A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468836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D8F8FC4-4CE3-BB80-2663-B04584DDF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D6666241-7610-7DAF-6779-673076A56B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3DBC7D34-8878-1CD0-49DE-585617CC35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5ABBFF95-BAEC-B9D6-601E-0617052D2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EC3C48D1-832B-B071-C906-79692E5896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803B0902-3B32-F059-F732-B6E98F7B1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770626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DA1927FE-CFA2-C230-2659-84A1D3C9AE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B1D722C5-8A07-43BF-7B90-B206631F6F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986546FC-95EE-F0EC-2A5A-76B41AB9CE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FD36A7-C548-43E1-94F7-04BA088DEC72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1E17C0FA-2A52-9FBA-E644-A4A4C3C404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164D5728-0B10-06B1-EC6E-2275DD8E21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2B989B-D3A6-4D59-ACF1-A3CFF520E116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51531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table of numbers and letters&#10;&#10;AI-generated content may be incorrect.">
            <a:extLst>
              <a:ext uri="{FF2B5EF4-FFF2-40B4-BE49-F238E27FC236}">
                <a16:creationId xmlns:a16="http://schemas.microsoft.com/office/drawing/2014/main" id="{1B4F0734-2951-E644-84DA-A31BE50407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3224" y="858207"/>
            <a:ext cx="2362775" cy="3838083"/>
          </a:xfrm>
          <a:prstGeom prst="rect">
            <a:avLst/>
          </a:prstGeom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130D76A9-3379-F9DA-864F-842E317BC547}"/>
              </a:ext>
            </a:extLst>
          </p:cNvPr>
          <p:cNvSpPr txBox="1"/>
          <p:nvPr/>
        </p:nvSpPr>
        <p:spPr>
          <a:xfrm>
            <a:off x="1201227" y="4696290"/>
            <a:ext cx="9392011" cy="2802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I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Figure S13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: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The Box–Behnken design for optimized condition of nanoparticle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842495917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14:29Z</dcterms:created>
  <dcterms:modified xsi:type="dcterms:W3CDTF">2026-02-22T09:15:18Z</dcterms:modified>
</cp:coreProperties>
</file>